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55448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C2600-48BF-4138-B8F7-235BA027C4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1398888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777960" y="3964320"/>
            <a:ext cx="1398888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4B73D-048B-4B0C-B690-0C42D97FFA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794592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777960" y="396432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7945920" y="396432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778B0-29BC-47C6-8A98-8AED13F096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5508000" y="160020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0237680" y="160020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777960" y="396432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5508000" y="396432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0237680" y="3964320"/>
            <a:ext cx="4504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9AA54-24EB-4B34-8D88-8D824479F2B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777960" y="1600200"/>
            <a:ext cx="1398888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612B6-E5A0-434B-A66C-980129F03D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1398888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7E4EE-C81C-4FD4-9D5A-C04004947D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68263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7945920" y="1600200"/>
            <a:ext cx="68263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3AD44-EB70-4F57-B07B-5BDCC8464F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5E7B98-17C4-4B3C-B3E2-7455E5CEB5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777960" y="274320"/>
            <a:ext cx="1398888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59C53-CFF4-4724-91F4-B02B0D5A9D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7945920" y="1600200"/>
            <a:ext cx="68263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777960" y="396432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66C74-4D62-4609-9CDF-1D3922028D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682632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794592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7945920" y="396432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168B4-18D6-457F-9955-1A82296004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77796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7945920" y="1600200"/>
            <a:ext cx="682632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777960" y="3964320"/>
            <a:ext cx="1398888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B4B097-3062-46B7-A69A-3FEB2B0786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777960" y="274320"/>
            <a:ext cx="1398888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777960" y="1600200"/>
            <a:ext cx="1398888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777960" y="6356520"/>
            <a:ext cx="362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5311800" y="6356520"/>
            <a:ext cx="492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1140920" y="6356520"/>
            <a:ext cx="362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4BDFA1-A3C0-408D-9B99-5D953F231CC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74"/>
          <p:cNvGrpSpPr/>
          <p:nvPr/>
        </p:nvGrpSpPr>
        <p:grpSpPr>
          <a:xfrm>
            <a:off x="0" y="149400"/>
            <a:ext cx="15468480" cy="6649200"/>
            <a:chOff x="0" y="149400"/>
            <a:chExt cx="15468480" cy="6649200"/>
          </a:xfrm>
        </p:grpSpPr>
        <p:grpSp>
          <p:nvGrpSpPr>
            <p:cNvPr id="42" name="Group 71"/>
            <p:cNvGrpSpPr/>
            <p:nvPr/>
          </p:nvGrpSpPr>
          <p:grpSpPr>
            <a:xfrm>
              <a:off x="151920" y="149400"/>
              <a:ext cx="15316560" cy="6649200"/>
              <a:chOff x="151920" y="149400"/>
              <a:chExt cx="15316560" cy="6649200"/>
            </a:xfrm>
          </p:grpSpPr>
          <p:grpSp>
            <p:nvGrpSpPr>
              <p:cNvPr id="43" name="Group 185"/>
              <p:cNvGrpSpPr/>
              <p:nvPr/>
            </p:nvGrpSpPr>
            <p:grpSpPr>
              <a:xfrm>
                <a:off x="152280" y="761760"/>
                <a:ext cx="15316200" cy="6036840"/>
                <a:chOff x="152280" y="761760"/>
                <a:chExt cx="15316200" cy="6036840"/>
              </a:xfrm>
            </p:grpSpPr>
            <p:grpSp>
              <p:nvGrpSpPr>
                <p:cNvPr id="44" name="Group 178"/>
                <p:cNvGrpSpPr/>
                <p:nvPr/>
              </p:nvGrpSpPr>
              <p:grpSpPr>
                <a:xfrm>
                  <a:off x="152280" y="761760"/>
                  <a:ext cx="15316200" cy="6036840"/>
                  <a:chOff x="152280" y="761760"/>
                  <a:chExt cx="15316200" cy="6036840"/>
                </a:xfrm>
              </p:grpSpPr>
              <p:sp>
                <p:nvSpPr>
                  <p:cNvPr id="45" name="Rectangle 177"/>
                  <p:cNvSpPr/>
                  <p:nvPr/>
                </p:nvSpPr>
                <p:spPr>
                  <a:xfrm>
                    <a:off x="152280" y="761760"/>
                    <a:ext cx="15316200" cy="1541520"/>
                  </a:xfrm>
                  <a:prstGeom prst="rect">
                    <a:avLst/>
                  </a:prstGeom>
                  <a:solidFill>
                    <a:srgbClr val="7030a0"/>
                  </a:solidFill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pic>
                <p:nvPicPr>
                  <p:cNvPr id="46" name="Picture 12" descr="C:\Users\Asus\Desktop\Dropbox\Lab110\LAB PAPER\manuscript\Experiment design\small\2h up.tiff"/>
                  <p:cNvPicPr/>
                  <p:nvPr/>
                </p:nvPicPr>
                <p:blipFill>
                  <a:blip r:embed="rId1"/>
                  <a:stretch/>
                </p:blipFill>
                <p:spPr>
                  <a:xfrm>
                    <a:off x="237960" y="834840"/>
                    <a:ext cx="2228400" cy="1321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7" name="Picture 13" descr="C:\Users\Asus\Desktop\Dropbox\Lab110\LAB PAPER\manuscript\Experiment design\small\4h up.tiff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2583000" y="834840"/>
                    <a:ext cx="2345040" cy="131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8" name="Picture 14" descr="C:\Users\Asus\Desktop\Dropbox\Lab110\LAB PAPER\manuscript\Experiment design\small\6h up.tiff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5006520" y="834840"/>
                    <a:ext cx="2345040" cy="131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9" name="Picture 15" descr="C:\Users\Asus\Desktop\Dropbox\Lab110\LAB PAPER\manuscript\Experiment design\small\2h down.tiff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043840" y="834840"/>
                    <a:ext cx="2278800" cy="127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0" name="Picture 16" descr="C:\Users\Asus\Desktop\Dropbox\Lab110\LAB PAPER\manuscript\Experiment design\small\4h down.tiff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10400760" y="834840"/>
                    <a:ext cx="2261160" cy="1266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1" name="Picture 17" descr="C:\Users\Asus\Desktop\Dropbox\Lab110\LAB PAPER\manuscript\Experiment design\small\6h down.tiff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2746160" y="834840"/>
                    <a:ext cx="2188800" cy="1248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cxnSp>
                <p:nvCxnSpPr>
                  <p:cNvPr id="52" name="Straight Arrow Connector 21"/>
                  <p:cNvCxnSpPr/>
                  <p:nvPr/>
                </p:nvCxnSpPr>
                <p:spPr>
                  <a:xfrm flipH="1">
                    <a:off x="2738880" y="1547280"/>
                    <a:ext cx="1017000" cy="102960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53" name="Picture 18" descr="C:\Users\Asus\Desktop\Dropbox\Lab110\LAB PAPER\manuscript\Experiment design\small\up acs.tiff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402480" y="2576520"/>
                    <a:ext cx="2336760" cy="14047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54" name="Straight Arrow Connector 24"/>
                  <p:cNvCxnSpPr/>
                  <p:nvPr/>
                </p:nvCxnSpPr>
                <p:spPr>
                  <a:xfrm flipH="1">
                    <a:off x="2504520" y="1547280"/>
                    <a:ext cx="3674880" cy="221688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55" name="Picture 19" descr="C:\Users\Asus\Desktop\Dropbox\Lab110\LAB PAPER\manuscript\Experiment design\small\down acs.tiff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8055720" y="3625200"/>
                    <a:ext cx="2336760" cy="140472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56" name="Straight Arrow Connector 36"/>
                  <p:cNvCxnSpPr/>
                  <p:nvPr/>
                </p:nvCxnSpPr>
                <p:spPr>
                  <a:xfrm flipH="1">
                    <a:off x="9852840" y="1547280"/>
                    <a:ext cx="1720440" cy="205848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57" name="Straight Arrow Connector 30"/>
                  <p:cNvCxnSpPr/>
                  <p:nvPr/>
                </p:nvCxnSpPr>
                <p:spPr>
                  <a:xfrm flipH="1">
                    <a:off x="10166040" y="1546200"/>
                    <a:ext cx="3674880" cy="324612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58" name="Straight Arrow Connector 39"/>
                  <p:cNvCxnSpPr/>
                  <p:nvPr/>
                </p:nvCxnSpPr>
                <p:spPr>
                  <a:xfrm flipH="1">
                    <a:off x="8602200" y="1469160"/>
                    <a:ext cx="626760" cy="21369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59" name="Straight Arrow Connector 20"/>
                  <p:cNvCxnSpPr/>
                  <p:nvPr/>
                </p:nvCxnSpPr>
                <p:spPr>
                  <a:xfrm flipH="1">
                    <a:off x="784440" y="1547280"/>
                    <a:ext cx="626040" cy="102960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60" name="Picture 20" descr="C:\Users\Asus\Desktop\Dropbox\Lab110\LAB PAPER\manuscript\Experiment design\small\up as-c.tiff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2817720" y="3734280"/>
                    <a:ext cx="2387520" cy="15336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61" name="Straight Arrow Connector 56"/>
                  <p:cNvCxnSpPr/>
                  <p:nvPr/>
                </p:nvCxnSpPr>
                <p:spPr>
                  <a:xfrm>
                    <a:off x="1176120" y="1626480"/>
                    <a:ext cx="1642320" cy="213768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62" name="Straight Arrow Connector 62"/>
                  <p:cNvCxnSpPr/>
                  <p:nvPr/>
                </p:nvCxnSpPr>
                <p:spPr>
                  <a:xfrm>
                    <a:off x="3441960" y="1626480"/>
                    <a:ext cx="1173240" cy="213768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63" name="Straight Arrow Connector 65"/>
                  <p:cNvCxnSpPr/>
                  <p:nvPr/>
                </p:nvCxnSpPr>
                <p:spPr>
                  <a:xfrm flipH="1">
                    <a:off x="4927680" y="1547280"/>
                    <a:ext cx="938520" cy="34041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64" name="Picture 21" descr="C:\Users\Asus\Desktop\Dropbox\Lab110\LAB PAPER\manuscript\Experiment design\small\up cs-a.tiff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5710320" y="2576520"/>
                    <a:ext cx="2266920" cy="14562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65" name="Straight Arrow Connector 70"/>
                  <p:cNvCxnSpPr/>
                  <p:nvPr/>
                </p:nvCxnSpPr>
                <p:spPr>
                  <a:xfrm>
                    <a:off x="1645200" y="1547280"/>
                    <a:ext cx="4065840" cy="11876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66" name="Straight Arrow Connector 73"/>
                  <p:cNvCxnSpPr/>
                  <p:nvPr/>
                </p:nvCxnSpPr>
                <p:spPr>
                  <a:xfrm>
                    <a:off x="3989880" y="1626480"/>
                    <a:ext cx="3440520" cy="95040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67" name="Straight Connector 83"/>
                  <p:cNvSpPr/>
                  <p:nvPr/>
                </p:nvSpPr>
                <p:spPr>
                  <a:xfrm>
                    <a:off x="6491880" y="1626480"/>
                    <a:ext cx="1954440" cy="5540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68" name="Straight Arrow Connector 84"/>
                  <p:cNvCxnSpPr/>
                  <p:nvPr/>
                </p:nvCxnSpPr>
                <p:spPr>
                  <a:xfrm flipH="1">
                    <a:off x="7742520" y="2180160"/>
                    <a:ext cx="704160" cy="15836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69" name="Picture 22" descr="C:\Users\Asus\Desktop\Dropbox\Lab110\LAB PAPER\manuscript\Experiment design\small\down as-c.tiff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10869840" y="4446720"/>
                    <a:ext cx="2264400" cy="14544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70" name="Straight Arrow Connector 93"/>
                  <p:cNvCxnSpPr/>
                  <p:nvPr/>
                </p:nvCxnSpPr>
                <p:spPr>
                  <a:xfrm>
                    <a:off x="8993880" y="1626120"/>
                    <a:ext cx="2189520" cy="285012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71" name="Straight Arrow Connector 96"/>
                  <p:cNvCxnSpPr/>
                  <p:nvPr/>
                </p:nvCxnSpPr>
                <p:spPr>
                  <a:xfrm>
                    <a:off x="11259720" y="1626120"/>
                    <a:ext cx="1329480" cy="285012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pic>
                <p:nvPicPr>
                  <p:cNvPr id="72" name="Picture 23" descr="C:\Users\Asus\Desktop\Dropbox\Lab110\LAB PAPER\manuscript\Experiment design\small\down cs-a.tiff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12801600" y="2670480"/>
                    <a:ext cx="2361960" cy="1443600"/>
                  </a:xfrm>
                  <a:prstGeom prst="rect">
                    <a:avLst/>
                  </a:prstGeom>
                  <a:ln w="9360">
                    <a:solidFill>
                      <a:srgbClr val="000000"/>
                    </a:solidFill>
                    <a:prstDash val="sysDot"/>
                    <a:miter/>
                  </a:ln>
                </p:spPr>
              </p:pic>
              <p:cxnSp>
                <p:nvCxnSpPr>
                  <p:cNvPr id="73" name="Straight Arrow Connector 99"/>
                  <p:cNvCxnSpPr/>
                  <p:nvPr/>
                </p:nvCxnSpPr>
                <p:spPr>
                  <a:xfrm flipH="1">
                    <a:off x="12980160" y="1546920"/>
                    <a:ext cx="626040" cy="411660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74" name="Straight Arrow Connector 104"/>
                  <p:cNvCxnSpPr/>
                  <p:nvPr/>
                </p:nvCxnSpPr>
                <p:spPr>
                  <a:xfrm>
                    <a:off x="9448200" y="1568880"/>
                    <a:ext cx="3353400" cy="11019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75" name="Straight Arrow Connector 106"/>
                  <p:cNvCxnSpPr/>
                  <p:nvPr/>
                </p:nvCxnSpPr>
                <p:spPr>
                  <a:xfrm>
                    <a:off x="11734560" y="1568880"/>
                    <a:ext cx="3353400" cy="11019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76" name="Straight Connector 107"/>
                  <p:cNvSpPr/>
                  <p:nvPr/>
                </p:nvSpPr>
                <p:spPr>
                  <a:xfrm>
                    <a:off x="14020920" y="1569240"/>
                    <a:ext cx="1295280" cy="3668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77" name="Straight Connector 109"/>
                  <p:cNvSpPr/>
                  <p:nvPr/>
                </p:nvSpPr>
                <p:spPr>
                  <a:xfrm flipH="1">
                    <a:off x="15315480" y="1937160"/>
                    <a:ext cx="1440" cy="1908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78" name="Straight Arrow Connector 112"/>
                  <p:cNvCxnSpPr/>
                  <p:nvPr/>
                </p:nvCxnSpPr>
                <p:spPr>
                  <a:xfrm flipH="1" flipV="1">
                    <a:off x="14934960" y="3844800"/>
                    <a:ext cx="381600" cy="21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79" name="TextBox 116"/>
                  <p:cNvSpPr/>
                  <p:nvPr/>
                </p:nvSpPr>
                <p:spPr>
                  <a:xfrm>
                    <a:off x="685440" y="4432680"/>
                    <a:ext cx="1904760" cy="641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up-regulated across all time points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, xylanase and GFP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80" name="Straight Arrow Connector 151"/>
                  <p:cNvCxnSpPr/>
                  <p:nvPr/>
                </p:nvCxnSpPr>
                <p:spPr>
                  <a:xfrm flipH="1">
                    <a:off x="1548720" y="3330000"/>
                    <a:ext cx="1080" cy="110196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81" name="Rounded Rectangle 156"/>
                  <p:cNvSpPr/>
                  <p:nvPr/>
                </p:nvSpPr>
                <p:spPr>
                  <a:xfrm>
                    <a:off x="685440" y="4432680"/>
                    <a:ext cx="1752480" cy="66060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82" name="Straight Arrow Connector 157"/>
                  <p:cNvCxnSpPr/>
                  <p:nvPr/>
                </p:nvCxnSpPr>
                <p:spPr>
                  <a:xfrm>
                    <a:off x="4037400" y="4579200"/>
                    <a:ext cx="1080" cy="8816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sp>
                <p:nvSpPr>
                  <p:cNvPr id="83" name="TextBox 159"/>
                  <p:cNvSpPr/>
                  <p:nvPr/>
                </p:nvSpPr>
                <p:spPr>
                  <a:xfrm>
                    <a:off x="3124080" y="5460480"/>
                    <a:ext cx="1904760" cy="824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up-regulated across all time points exclusively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 and xylanase but not in GFP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4" name="Rounded Rectangle 160"/>
                  <p:cNvSpPr/>
                  <p:nvPr/>
                </p:nvSpPr>
                <p:spPr>
                  <a:xfrm>
                    <a:off x="3124080" y="5460480"/>
                    <a:ext cx="1752480" cy="80748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5" name="TextBox 161"/>
                  <p:cNvSpPr/>
                  <p:nvPr/>
                </p:nvSpPr>
                <p:spPr>
                  <a:xfrm>
                    <a:off x="5943600" y="4285800"/>
                    <a:ext cx="1904760" cy="824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up-regulated across all time points exclusively in xylanase and GFP but not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6" name="Rounded Rectangle 162"/>
                  <p:cNvSpPr/>
                  <p:nvPr/>
                </p:nvSpPr>
                <p:spPr>
                  <a:xfrm>
                    <a:off x="5943600" y="4285800"/>
                    <a:ext cx="1752480" cy="80748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7" name="TextBox 163"/>
                  <p:cNvSpPr/>
                  <p:nvPr/>
                </p:nvSpPr>
                <p:spPr>
                  <a:xfrm>
                    <a:off x="8381880" y="5240160"/>
                    <a:ext cx="2057400" cy="641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down-regulated across all time points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, xylanase and GFP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8" name="Rounded Rectangle 164"/>
                  <p:cNvSpPr/>
                  <p:nvPr/>
                </p:nvSpPr>
                <p:spPr>
                  <a:xfrm>
                    <a:off x="8381880" y="5240160"/>
                    <a:ext cx="1981080" cy="66060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89" name="TextBox 165"/>
                  <p:cNvSpPr/>
                  <p:nvPr/>
                </p:nvSpPr>
                <p:spPr>
                  <a:xfrm>
                    <a:off x="13258800" y="4579560"/>
                    <a:ext cx="2133360" cy="824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down-regulated across all time points exclusively in xylanase and GFP but not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0" name="Rounded Rectangle 166"/>
                  <p:cNvSpPr/>
                  <p:nvPr/>
                </p:nvSpPr>
                <p:spPr>
                  <a:xfrm>
                    <a:off x="13258800" y="4579560"/>
                    <a:ext cx="2057400" cy="80748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1" name="TextBox 167"/>
                  <p:cNvSpPr/>
                  <p:nvPr/>
                </p:nvSpPr>
                <p:spPr>
                  <a:xfrm>
                    <a:off x="11125080" y="5974560"/>
                    <a:ext cx="2133360" cy="824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Set of genes down-regulated across all time points exclusively in rhIFN-</a:t>
                    </a:r>
                    <a:r>
                      <a:rPr b="0" lang="el-GR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β</a:t>
                    </a:r>
                    <a:r>
                      <a:rPr b="0" lang="en-US" sz="1200" spc="-1" strike="noStrike">
                        <a:solidFill>
                          <a:srgbClr val="000000"/>
                        </a:solidFill>
                        <a:latin typeface="Calibri"/>
                      </a:rPr>
                      <a:t> and xylanase but not in GFP.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92" name="Rounded Rectangle 168"/>
                  <p:cNvSpPr/>
                  <p:nvPr/>
                </p:nvSpPr>
                <p:spPr>
                  <a:xfrm>
                    <a:off x="11125080" y="5974560"/>
                    <a:ext cx="1904760" cy="807480"/>
                  </a:xfrm>
                  <a:prstGeom prst="roundRect">
                    <a:avLst>
                      <a:gd name="adj" fmla="val 16667"/>
                    </a:avLst>
                  </a:prstGeom>
                  <a:noFill/>
                  <a:ln w="25560">
                    <a:solidFill>
                      <a:srgbClr val="385d8a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cxnSp>
                <p:nvCxnSpPr>
                  <p:cNvPr id="93" name="Straight Arrow Connector 169"/>
                  <p:cNvCxnSpPr/>
                  <p:nvPr/>
                </p:nvCxnSpPr>
                <p:spPr>
                  <a:xfrm>
                    <a:off x="6856920" y="3316680"/>
                    <a:ext cx="1080" cy="9698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94" name="Straight Arrow Connector 170"/>
                  <p:cNvCxnSpPr/>
                  <p:nvPr/>
                </p:nvCxnSpPr>
                <p:spPr>
                  <a:xfrm>
                    <a:off x="9218880" y="4344120"/>
                    <a:ext cx="1080" cy="8816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95" name="Straight Arrow Connector 172"/>
                  <p:cNvCxnSpPr/>
                  <p:nvPr/>
                </p:nvCxnSpPr>
                <p:spPr>
                  <a:xfrm>
                    <a:off x="12038400" y="5166720"/>
                    <a:ext cx="1080" cy="79344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  <p:cxnSp>
                <p:nvCxnSpPr>
                  <p:cNvPr id="96" name="Straight Arrow Connector 173"/>
                  <p:cNvCxnSpPr/>
                  <p:nvPr/>
                </p:nvCxnSpPr>
                <p:spPr>
                  <a:xfrm>
                    <a:off x="14019840" y="3433680"/>
                    <a:ext cx="1080" cy="1145880"/>
                  </a:xfrm>
                  <a:prstGeom prst="straightConnector1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arrow" w="med"/>
                  </a:ln>
                </p:spPr>
              </p:cxnSp>
            </p:grpSp>
            <p:sp>
              <p:nvSpPr>
                <p:cNvPr id="97" name="TextBox 179"/>
                <p:cNvSpPr/>
                <p:nvPr/>
              </p:nvSpPr>
              <p:spPr>
                <a:xfrm>
                  <a:off x="1371240" y="518184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b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8" name="TextBox 180"/>
                <p:cNvSpPr/>
                <p:nvPr/>
              </p:nvSpPr>
              <p:spPr>
                <a:xfrm>
                  <a:off x="3733560" y="634176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c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9" name="TextBox 181"/>
                <p:cNvSpPr/>
                <p:nvPr/>
              </p:nvSpPr>
              <p:spPr>
                <a:xfrm>
                  <a:off x="6629400" y="516672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d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0" name="TextBox 182"/>
                <p:cNvSpPr/>
                <p:nvPr/>
              </p:nvSpPr>
              <p:spPr>
                <a:xfrm>
                  <a:off x="9067680" y="597456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e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1" name="TextBox 183"/>
                <p:cNvSpPr/>
                <p:nvPr/>
              </p:nvSpPr>
              <p:spPr>
                <a:xfrm>
                  <a:off x="13030200" y="648864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f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02" name="TextBox 184"/>
                <p:cNvSpPr/>
                <p:nvPr/>
              </p:nvSpPr>
              <p:spPr>
                <a:xfrm>
                  <a:off x="14096880" y="5460480"/>
                  <a:ext cx="45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Calibri"/>
                    </a:rPr>
                    <a:t>(g)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03" name="TextBox 186"/>
              <p:cNvSpPr/>
              <p:nvPr/>
            </p:nvSpPr>
            <p:spPr>
              <a:xfrm>
                <a:off x="10666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2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TextBox 187"/>
              <p:cNvSpPr/>
              <p:nvPr/>
            </p:nvSpPr>
            <p:spPr>
              <a:xfrm>
                <a:off x="35812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TextBox 188"/>
              <p:cNvSpPr/>
              <p:nvPr/>
            </p:nvSpPr>
            <p:spPr>
              <a:xfrm>
                <a:off x="58672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6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TextBox 189"/>
              <p:cNvSpPr/>
              <p:nvPr/>
            </p:nvSpPr>
            <p:spPr>
              <a:xfrm>
                <a:off x="90676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2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TextBox 190"/>
              <p:cNvSpPr/>
              <p:nvPr/>
            </p:nvSpPr>
            <p:spPr>
              <a:xfrm>
                <a:off x="113536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4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8" name="TextBox 191"/>
              <p:cNvSpPr/>
              <p:nvPr/>
            </p:nvSpPr>
            <p:spPr>
              <a:xfrm>
                <a:off x="13639680" y="533160"/>
                <a:ext cx="45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6h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9" name="Left Brace 192"/>
              <p:cNvSpPr/>
              <p:nvPr/>
            </p:nvSpPr>
            <p:spPr>
              <a:xfrm rot="5400000">
                <a:off x="3638160" y="-3029040"/>
                <a:ext cx="190440" cy="7162920"/>
              </a:xfrm>
              <a:custGeom>
                <a:avLst/>
                <a:gdLst>
                  <a:gd name="textAreaLeft" fmla="*/ 121680 w 190440"/>
                  <a:gd name="textAreaRight" fmla="*/ 190800 w 190440"/>
                  <a:gd name="textAreaTop" fmla="*/ 4680 h 7162920"/>
                  <a:gd name="textAreaBottom" fmla="*/ 7158240 h 7162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24"/>
                      <a:pt x="10800" y="48"/>
                    </a:cubicBezTo>
                    <a:lnTo>
                      <a:pt x="10800" y="10752"/>
                    </a:lnTo>
                    <a:cubicBezTo>
                      <a:pt x="10800" y="10776"/>
                      <a:pt x="5400" y="10800"/>
                      <a:pt x="0" y="10800"/>
                    </a:cubicBezTo>
                    <a:cubicBezTo>
                      <a:pt x="5400" y="10800"/>
                      <a:pt x="10800" y="10824"/>
                      <a:pt x="10800" y="10848"/>
                    </a:cubicBezTo>
                    <a:lnTo>
                      <a:pt x="10800" y="21552"/>
                    </a:lnTo>
                    <a:cubicBezTo>
                      <a:pt x="10800" y="21576"/>
                      <a:pt x="16200" y="21600"/>
                      <a:pt x="21600" y="21600"/>
                    </a:cubicBezTo>
                  </a:path>
                </a:pathLst>
              </a:custGeom>
              <a:noFill/>
              <a:ln w="25560">
                <a:solidFill>
                  <a:srgbClr val="000000"/>
                </a:solidFill>
                <a:miter/>
              </a:ln>
              <a:effectLst>
                <a:outerShdw dist="20160" dir="5400000" blurRad="0" rotWithShape="0">
                  <a:srgbClr val="000000">
                    <a:alpha val="38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Left Brace 193"/>
              <p:cNvSpPr/>
              <p:nvPr/>
            </p:nvSpPr>
            <p:spPr>
              <a:xfrm rot="5400000">
                <a:off x="11486880" y="-3029040"/>
                <a:ext cx="190440" cy="7162920"/>
              </a:xfrm>
              <a:custGeom>
                <a:avLst/>
                <a:gdLst>
                  <a:gd name="textAreaLeft" fmla="*/ 121680 w 190440"/>
                  <a:gd name="textAreaRight" fmla="*/ 190800 w 190440"/>
                  <a:gd name="textAreaTop" fmla="*/ 4680 h 7162920"/>
                  <a:gd name="textAreaBottom" fmla="*/ 7158240 h 71629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24"/>
                      <a:pt x="10800" y="48"/>
                    </a:cubicBezTo>
                    <a:lnTo>
                      <a:pt x="10800" y="10752"/>
                    </a:lnTo>
                    <a:cubicBezTo>
                      <a:pt x="10800" y="10776"/>
                      <a:pt x="5400" y="10800"/>
                      <a:pt x="0" y="10800"/>
                    </a:cubicBezTo>
                    <a:cubicBezTo>
                      <a:pt x="5400" y="10800"/>
                      <a:pt x="10800" y="10824"/>
                      <a:pt x="10800" y="10848"/>
                    </a:cubicBezTo>
                    <a:lnTo>
                      <a:pt x="10800" y="21552"/>
                    </a:lnTo>
                    <a:cubicBezTo>
                      <a:pt x="10800" y="21576"/>
                      <a:pt x="16200" y="21600"/>
                      <a:pt x="21600" y="21600"/>
                    </a:cubicBezTo>
                  </a:path>
                </a:pathLst>
              </a:custGeom>
              <a:noFill/>
              <a:ln w="25560">
                <a:solidFill>
                  <a:srgbClr val="000000"/>
                </a:solidFill>
                <a:miter/>
              </a:ln>
              <a:effectLst>
                <a:outerShdw dist="20160" dir="5400000" blurRad="0" rotWithShape="0">
                  <a:srgbClr val="000000">
                    <a:alpha val="38000"/>
                  </a:srgbClr>
                </a:outerShdw>
              </a:effectLst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TextBox 194"/>
              <p:cNvSpPr/>
              <p:nvPr/>
            </p:nvSpPr>
            <p:spPr>
              <a:xfrm>
                <a:off x="2895480" y="152280"/>
                <a:ext cx="3200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Set of up-regulated genes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TextBox 195"/>
              <p:cNvSpPr/>
              <p:nvPr/>
            </p:nvSpPr>
            <p:spPr>
              <a:xfrm>
                <a:off x="10363320" y="149400"/>
                <a:ext cx="3200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Calibri"/>
                  </a:rPr>
                  <a:t>Set of down-regulated genes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13" name="TextBox 72"/>
            <p:cNvSpPr/>
            <p:nvPr/>
          </p:nvSpPr>
          <p:spPr>
            <a:xfrm>
              <a:off x="0" y="2286000"/>
              <a:ext cx="45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Calibri"/>
                </a:rPr>
                <a:t>(a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8T11:55:21Z</dcterms:created>
  <dc:creator>Asus</dc:creator>
  <dc:description/>
  <dc:language>en-US</dc:language>
  <cp:lastModifiedBy>Asus</cp:lastModifiedBy>
  <dcterms:modified xsi:type="dcterms:W3CDTF">2011-06-26T09:36:00Z</dcterms:modified>
  <cp:revision>24</cp:revision>
  <dc:subject/>
  <dc:title>Slide 1</dc:title>
</cp:coreProperties>
</file>